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7488238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50" d="100"/>
          <a:sy n="50" d="100"/>
        </p:scale>
        <p:origin x="3594" y="6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1618" y="1995312"/>
            <a:ext cx="6365002" cy="4244622"/>
          </a:xfrm>
        </p:spPr>
        <p:txBody>
          <a:bodyPr anchor="b"/>
          <a:lstStyle>
            <a:lvl1pPr algn="ctr">
              <a:defRPr sz="4913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36030" y="6403623"/>
            <a:ext cx="5616179" cy="2943577"/>
          </a:xfrm>
        </p:spPr>
        <p:txBody>
          <a:bodyPr/>
          <a:lstStyle>
            <a:lvl1pPr marL="0" indent="0" algn="ctr">
              <a:buNone/>
              <a:defRPr sz="1965"/>
            </a:lvl1pPr>
            <a:lvl2pPr marL="374401" indent="0" algn="ctr">
              <a:buNone/>
              <a:defRPr sz="1638"/>
            </a:lvl2pPr>
            <a:lvl3pPr marL="748802" indent="0" algn="ctr">
              <a:buNone/>
              <a:defRPr sz="1474"/>
            </a:lvl3pPr>
            <a:lvl4pPr marL="1123203" indent="0" algn="ctr">
              <a:buNone/>
              <a:defRPr sz="1310"/>
            </a:lvl4pPr>
            <a:lvl5pPr marL="1497604" indent="0" algn="ctr">
              <a:buNone/>
              <a:defRPr sz="1310"/>
            </a:lvl5pPr>
            <a:lvl6pPr marL="1872005" indent="0" algn="ctr">
              <a:buNone/>
              <a:defRPr sz="1310"/>
            </a:lvl6pPr>
            <a:lvl7pPr marL="2246406" indent="0" algn="ctr">
              <a:buNone/>
              <a:defRPr sz="1310"/>
            </a:lvl7pPr>
            <a:lvl8pPr marL="2620808" indent="0" algn="ctr">
              <a:buNone/>
              <a:defRPr sz="1310"/>
            </a:lvl8pPr>
            <a:lvl9pPr marL="2995209" indent="0" algn="ctr">
              <a:buNone/>
              <a:defRPr sz="1310"/>
            </a:lvl9pPr>
          </a:lstStyle>
          <a:p>
            <a:r>
              <a:rPr lang="nl-NL" smtClean="0"/>
              <a:t>Klik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8B28-E595-42EA-9C8F-FF27AEFEB79A}" type="datetimeFigureOut">
              <a:rPr lang="nl-NL" smtClean="0"/>
              <a:t>12-12-2024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E4A5C-9188-48DF-B84A-C42CC9DCE3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26596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8B28-E595-42EA-9C8F-FF27AEFEB79A}" type="datetimeFigureOut">
              <a:rPr lang="nl-NL" smtClean="0"/>
              <a:t>12-12-2024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E4A5C-9188-48DF-B84A-C42CC9DCE3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828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58771" y="649111"/>
            <a:ext cx="1614651" cy="10332156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4817" y="649111"/>
            <a:ext cx="4750351" cy="10332156"/>
          </a:xfrm>
        </p:spPr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8B28-E595-42EA-9C8F-FF27AEFEB79A}" type="datetimeFigureOut">
              <a:rPr lang="nl-NL" smtClean="0"/>
              <a:t>12-12-2024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E4A5C-9188-48DF-B84A-C42CC9DCE3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389473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8B28-E595-42EA-9C8F-FF27AEFEB79A}" type="datetimeFigureOut">
              <a:rPr lang="nl-NL" smtClean="0"/>
              <a:t>12-12-2024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E4A5C-9188-48DF-B84A-C42CC9DCE3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47930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0917" y="3039537"/>
            <a:ext cx="6458605" cy="5071532"/>
          </a:xfrm>
        </p:spPr>
        <p:txBody>
          <a:bodyPr anchor="b"/>
          <a:lstStyle>
            <a:lvl1pPr>
              <a:defRPr sz="4913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0917" y="8159048"/>
            <a:ext cx="6458605" cy="2666999"/>
          </a:xfrm>
        </p:spPr>
        <p:txBody>
          <a:bodyPr/>
          <a:lstStyle>
            <a:lvl1pPr marL="0" indent="0">
              <a:buNone/>
              <a:defRPr sz="1965">
                <a:solidFill>
                  <a:schemeClr val="tx1"/>
                </a:solidFill>
              </a:defRPr>
            </a:lvl1pPr>
            <a:lvl2pPr marL="374401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2pPr>
            <a:lvl3pPr marL="748802" indent="0">
              <a:buNone/>
              <a:defRPr sz="1474">
                <a:solidFill>
                  <a:schemeClr val="tx1">
                    <a:tint val="75000"/>
                  </a:schemeClr>
                </a:solidFill>
              </a:defRPr>
            </a:lvl3pPr>
            <a:lvl4pPr marL="1123203" indent="0">
              <a:buNone/>
              <a:defRPr sz="1310">
                <a:solidFill>
                  <a:schemeClr val="tx1">
                    <a:tint val="75000"/>
                  </a:schemeClr>
                </a:solidFill>
              </a:defRPr>
            </a:lvl4pPr>
            <a:lvl5pPr marL="1497604" indent="0">
              <a:buNone/>
              <a:defRPr sz="1310">
                <a:solidFill>
                  <a:schemeClr val="tx1">
                    <a:tint val="75000"/>
                  </a:schemeClr>
                </a:solidFill>
              </a:defRPr>
            </a:lvl5pPr>
            <a:lvl6pPr marL="1872005" indent="0">
              <a:buNone/>
              <a:defRPr sz="1310">
                <a:solidFill>
                  <a:schemeClr val="tx1">
                    <a:tint val="75000"/>
                  </a:schemeClr>
                </a:solidFill>
              </a:defRPr>
            </a:lvl6pPr>
            <a:lvl7pPr marL="2246406" indent="0">
              <a:buNone/>
              <a:defRPr sz="1310">
                <a:solidFill>
                  <a:schemeClr val="tx1">
                    <a:tint val="75000"/>
                  </a:schemeClr>
                </a:solidFill>
              </a:defRPr>
            </a:lvl7pPr>
            <a:lvl8pPr marL="2620808" indent="0">
              <a:buNone/>
              <a:defRPr sz="1310">
                <a:solidFill>
                  <a:schemeClr val="tx1">
                    <a:tint val="75000"/>
                  </a:schemeClr>
                </a:solidFill>
              </a:defRPr>
            </a:lvl8pPr>
            <a:lvl9pPr marL="2995209" indent="0">
              <a:buNone/>
              <a:defRPr sz="131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8B28-E595-42EA-9C8F-FF27AEFEB79A}" type="datetimeFigureOut">
              <a:rPr lang="nl-NL" smtClean="0"/>
              <a:t>12-12-2024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E4A5C-9188-48DF-B84A-C42CC9DCE3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183532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4816" y="3245556"/>
            <a:ext cx="3182501" cy="7735712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90921" y="3245556"/>
            <a:ext cx="3182501" cy="7735712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8B28-E595-42EA-9C8F-FF27AEFEB79A}" type="datetimeFigureOut">
              <a:rPr lang="nl-NL" smtClean="0"/>
              <a:t>12-12-2024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E4A5C-9188-48DF-B84A-C42CC9DCE3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202457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2" y="649114"/>
            <a:ext cx="6458605" cy="2356556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3" y="2988734"/>
            <a:ext cx="3167875" cy="1464732"/>
          </a:xfrm>
        </p:spPr>
        <p:txBody>
          <a:bodyPr anchor="b"/>
          <a:lstStyle>
            <a:lvl1pPr marL="0" indent="0">
              <a:buNone/>
              <a:defRPr sz="1965" b="1"/>
            </a:lvl1pPr>
            <a:lvl2pPr marL="374401" indent="0">
              <a:buNone/>
              <a:defRPr sz="1638" b="1"/>
            </a:lvl2pPr>
            <a:lvl3pPr marL="748802" indent="0">
              <a:buNone/>
              <a:defRPr sz="1474" b="1"/>
            </a:lvl3pPr>
            <a:lvl4pPr marL="1123203" indent="0">
              <a:buNone/>
              <a:defRPr sz="1310" b="1"/>
            </a:lvl4pPr>
            <a:lvl5pPr marL="1497604" indent="0">
              <a:buNone/>
              <a:defRPr sz="1310" b="1"/>
            </a:lvl5pPr>
            <a:lvl6pPr marL="1872005" indent="0">
              <a:buNone/>
              <a:defRPr sz="1310" b="1"/>
            </a:lvl6pPr>
            <a:lvl7pPr marL="2246406" indent="0">
              <a:buNone/>
              <a:defRPr sz="1310" b="1"/>
            </a:lvl7pPr>
            <a:lvl8pPr marL="2620808" indent="0">
              <a:buNone/>
              <a:defRPr sz="1310" b="1"/>
            </a:lvl8pPr>
            <a:lvl9pPr marL="2995209" indent="0">
              <a:buNone/>
              <a:defRPr sz="1310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5793" y="4453467"/>
            <a:ext cx="3167875" cy="6550379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90921" y="2988734"/>
            <a:ext cx="3183476" cy="1464732"/>
          </a:xfrm>
        </p:spPr>
        <p:txBody>
          <a:bodyPr anchor="b"/>
          <a:lstStyle>
            <a:lvl1pPr marL="0" indent="0">
              <a:buNone/>
              <a:defRPr sz="1965" b="1"/>
            </a:lvl1pPr>
            <a:lvl2pPr marL="374401" indent="0">
              <a:buNone/>
              <a:defRPr sz="1638" b="1"/>
            </a:lvl2pPr>
            <a:lvl3pPr marL="748802" indent="0">
              <a:buNone/>
              <a:defRPr sz="1474" b="1"/>
            </a:lvl3pPr>
            <a:lvl4pPr marL="1123203" indent="0">
              <a:buNone/>
              <a:defRPr sz="1310" b="1"/>
            </a:lvl4pPr>
            <a:lvl5pPr marL="1497604" indent="0">
              <a:buNone/>
              <a:defRPr sz="1310" b="1"/>
            </a:lvl5pPr>
            <a:lvl6pPr marL="1872005" indent="0">
              <a:buNone/>
              <a:defRPr sz="1310" b="1"/>
            </a:lvl6pPr>
            <a:lvl7pPr marL="2246406" indent="0">
              <a:buNone/>
              <a:defRPr sz="1310" b="1"/>
            </a:lvl7pPr>
            <a:lvl8pPr marL="2620808" indent="0">
              <a:buNone/>
              <a:defRPr sz="1310" b="1"/>
            </a:lvl8pPr>
            <a:lvl9pPr marL="2995209" indent="0">
              <a:buNone/>
              <a:defRPr sz="1310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90921" y="4453467"/>
            <a:ext cx="3183476" cy="6550379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8B28-E595-42EA-9C8F-FF27AEFEB79A}" type="datetimeFigureOut">
              <a:rPr lang="nl-NL" smtClean="0"/>
              <a:t>12-12-2024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E4A5C-9188-48DF-B84A-C42CC9DCE3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623227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8B28-E595-42EA-9C8F-FF27AEFEB79A}" type="datetimeFigureOut">
              <a:rPr lang="nl-NL" smtClean="0"/>
              <a:t>12-12-2024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E4A5C-9188-48DF-B84A-C42CC9DCE3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9823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8B28-E595-42EA-9C8F-FF27AEFEB79A}" type="datetimeFigureOut">
              <a:rPr lang="nl-NL" smtClean="0"/>
              <a:t>12-12-2024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E4A5C-9188-48DF-B84A-C42CC9DCE3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92488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2" y="812800"/>
            <a:ext cx="2415152" cy="2844800"/>
          </a:xfrm>
        </p:spPr>
        <p:txBody>
          <a:bodyPr anchor="b"/>
          <a:lstStyle>
            <a:lvl1pPr>
              <a:defRPr sz="2620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83477" y="1755425"/>
            <a:ext cx="3790920" cy="8664222"/>
          </a:xfrm>
        </p:spPr>
        <p:txBody>
          <a:bodyPr/>
          <a:lstStyle>
            <a:lvl1pPr>
              <a:defRPr sz="2620"/>
            </a:lvl1pPr>
            <a:lvl2pPr>
              <a:defRPr sz="2293"/>
            </a:lvl2pPr>
            <a:lvl3pPr>
              <a:defRPr sz="1965"/>
            </a:lvl3pPr>
            <a:lvl4pPr>
              <a:defRPr sz="1638"/>
            </a:lvl4pPr>
            <a:lvl5pPr>
              <a:defRPr sz="1638"/>
            </a:lvl5pPr>
            <a:lvl6pPr>
              <a:defRPr sz="1638"/>
            </a:lvl6pPr>
            <a:lvl7pPr>
              <a:defRPr sz="1638"/>
            </a:lvl7pPr>
            <a:lvl8pPr>
              <a:defRPr sz="1638"/>
            </a:lvl8pPr>
            <a:lvl9pPr>
              <a:defRPr sz="1638"/>
            </a:lvl9pPr>
          </a:lstStyle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5792" y="3657600"/>
            <a:ext cx="2415152" cy="6776156"/>
          </a:xfrm>
        </p:spPr>
        <p:txBody>
          <a:bodyPr/>
          <a:lstStyle>
            <a:lvl1pPr marL="0" indent="0">
              <a:buNone/>
              <a:defRPr sz="1310"/>
            </a:lvl1pPr>
            <a:lvl2pPr marL="374401" indent="0">
              <a:buNone/>
              <a:defRPr sz="1146"/>
            </a:lvl2pPr>
            <a:lvl3pPr marL="748802" indent="0">
              <a:buNone/>
              <a:defRPr sz="983"/>
            </a:lvl3pPr>
            <a:lvl4pPr marL="1123203" indent="0">
              <a:buNone/>
              <a:defRPr sz="819"/>
            </a:lvl4pPr>
            <a:lvl5pPr marL="1497604" indent="0">
              <a:buNone/>
              <a:defRPr sz="819"/>
            </a:lvl5pPr>
            <a:lvl6pPr marL="1872005" indent="0">
              <a:buNone/>
              <a:defRPr sz="819"/>
            </a:lvl6pPr>
            <a:lvl7pPr marL="2246406" indent="0">
              <a:buNone/>
              <a:defRPr sz="819"/>
            </a:lvl7pPr>
            <a:lvl8pPr marL="2620808" indent="0">
              <a:buNone/>
              <a:defRPr sz="819"/>
            </a:lvl8pPr>
            <a:lvl9pPr marL="2995209" indent="0">
              <a:buNone/>
              <a:defRPr sz="819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8B28-E595-42EA-9C8F-FF27AEFEB79A}" type="datetimeFigureOut">
              <a:rPr lang="nl-NL" smtClean="0"/>
              <a:t>12-12-2024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E4A5C-9188-48DF-B84A-C42CC9DCE3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58501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2" y="812800"/>
            <a:ext cx="2415152" cy="2844800"/>
          </a:xfrm>
        </p:spPr>
        <p:txBody>
          <a:bodyPr anchor="b"/>
          <a:lstStyle>
            <a:lvl1pPr>
              <a:defRPr sz="2620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83477" y="1755425"/>
            <a:ext cx="3790920" cy="8664222"/>
          </a:xfrm>
        </p:spPr>
        <p:txBody>
          <a:bodyPr anchor="t"/>
          <a:lstStyle>
            <a:lvl1pPr marL="0" indent="0">
              <a:buNone/>
              <a:defRPr sz="2620"/>
            </a:lvl1pPr>
            <a:lvl2pPr marL="374401" indent="0">
              <a:buNone/>
              <a:defRPr sz="2293"/>
            </a:lvl2pPr>
            <a:lvl3pPr marL="748802" indent="0">
              <a:buNone/>
              <a:defRPr sz="1965"/>
            </a:lvl3pPr>
            <a:lvl4pPr marL="1123203" indent="0">
              <a:buNone/>
              <a:defRPr sz="1638"/>
            </a:lvl4pPr>
            <a:lvl5pPr marL="1497604" indent="0">
              <a:buNone/>
              <a:defRPr sz="1638"/>
            </a:lvl5pPr>
            <a:lvl6pPr marL="1872005" indent="0">
              <a:buNone/>
              <a:defRPr sz="1638"/>
            </a:lvl6pPr>
            <a:lvl7pPr marL="2246406" indent="0">
              <a:buNone/>
              <a:defRPr sz="1638"/>
            </a:lvl7pPr>
            <a:lvl8pPr marL="2620808" indent="0">
              <a:buNone/>
              <a:defRPr sz="1638"/>
            </a:lvl8pPr>
            <a:lvl9pPr marL="2995209" indent="0">
              <a:buNone/>
              <a:defRPr sz="1638"/>
            </a:lvl9pPr>
          </a:lstStyle>
          <a:p>
            <a:r>
              <a:rPr lang="nl-NL" smtClean="0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5792" y="3657600"/>
            <a:ext cx="2415152" cy="6776156"/>
          </a:xfrm>
        </p:spPr>
        <p:txBody>
          <a:bodyPr/>
          <a:lstStyle>
            <a:lvl1pPr marL="0" indent="0">
              <a:buNone/>
              <a:defRPr sz="1310"/>
            </a:lvl1pPr>
            <a:lvl2pPr marL="374401" indent="0">
              <a:buNone/>
              <a:defRPr sz="1146"/>
            </a:lvl2pPr>
            <a:lvl3pPr marL="748802" indent="0">
              <a:buNone/>
              <a:defRPr sz="983"/>
            </a:lvl3pPr>
            <a:lvl4pPr marL="1123203" indent="0">
              <a:buNone/>
              <a:defRPr sz="819"/>
            </a:lvl4pPr>
            <a:lvl5pPr marL="1497604" indent="0">
              <a:buNone/>
              <a:defRPr sz="819"/>
            </a:lvl5pPr>
            <a:lvl6pPr marL="1872005" indent="0">
              <a:buNone/>
              <a:defRPr sz="819"/>
            </a:lvl6pPr>
            <a:lvl7pPr marL="2246406" indent="0">
              <a:buNone/>
              <a:defRPr sz="819"/>
            </a:lvl7pPr>
            <a:lvl8pPr marL="2620808" indent="0">
              <a:buNone/>
              <a:defRPr sz="819"/>
            </a:lvl8pPr>
            <a:lvl9pPr marL="2995209" indent="0">
              <a:buNone/>
              <a:defRPr sz="819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88B28-E595-42EA-9C8F-FF27AEFEB79A}" type="datetimeFigureOut">
              <a:rPr lang="nl-NL" smtClean="0"/>
              <a:t>12-12-2024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E4A5C-9188-48DF-B84A-C42CC9DCE3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354660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4817" y="649114"/>
            <a:ext cx="645860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4817" y="3245556"/>
            <a:ext cx="645860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4816" y="11300181"/>
            <a:ext cx="1684854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388B28-E595-42EA-9C8F-FF27AEFEB79A}" type="datetimeFigureOut">
              <a:rPr lang="nl-NL" smtClean="0"/>
              <a:t>12-12-2024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80479" y="11300181"/>
            <a:ext cx="252728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288568" y="11300181"/>
            <a:ext cx="1684854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FE4A5C-9188-48DF-B84A-C42CC9DCE3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57688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48802" rtl="0" eaLnBrk="1" latinLnBrk="0" hangingPunct="1">
        <a:lnSpc>
          <a:spcPct val="90000"/>
        </a:lnSpc>
        <a:spcBef>
          <a:spcPct val="0"/>
        </a:spcBef>
        <a:buNone/>
        <a:defRPr sz="360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7201" indent="-187201" algn="l" defTabSz="748802" rtl="0" eaLnBrk="1" latinLnBrk="0" hangingPunct="1">
        <a:lnSpc>
          <a:spcPct val="90000"/>
        </a:lnSpc>
        <a:spcBef>
          <a:spcPts val="819"/>
        </a:spcBef>
        <a:buFont typeface="Arial" panose="020B0604020202020204" pitchFamily="34" charset="0"/>
        <a:buChar char="•"/>
        <a:defRPr sz="2293" kern="1200">
          <a:solidFill>
            <a:schemeClr val="tx1"/>
          </a:solidFill>
          <a:latin typeface="+mn-lt"/>
          <a:ea typeface="+mn-ea"/>
          <a:cs typeface="+mn-cs"/>
        </a:defRPr>
      </a:lvl1pPr>
      <a:lvl2pPr marL="561602" indent="-187201" algn="l" defTabSz="748802" rtl="0" eaLnBrk="1" latinLnBrk="0" hangingPunct="1">
        <a:lnSpc>
          <a:spcPct val="90000"/>
        </a:lnSpc>
        <a:spcBef>
          <a:spcPts val="409"/>
        </a:spcBef>
        <a:buFont typeface="Arial" panose="020B0604020202020204" pitchFamily="34" charset="0"/>
        <a:buChar char="•"/>
        <a:defRPr sz="1965" kern="1200">
          <a:solidFill>
            <a:schemeClr val="tx1"/>
          </a:solidFill>
          <a:latin typeface="+mn-lt"/>
          <a:ea typeface="+mn-ea"/>
          <a:cs typeface="+mn-cs"/>
        </a:defRPr>
      </a:lvl2pPr>
      <a:lvl3pPr marL="936003" indent="-187201" algn="l" defTabSz="748802" rtl="0" eaLnBrk="1" latinLnBrk="0" hangingPunct="1">
        <a:lnSpc>
          <a:spcPct val="90000"/>
        </a:lnSpc>
        <a:spcBef>
          <a:spcPts val="409"/>
        </a:spcBef>
        <a:buFont typeface="Arial" panose="020B0604020202020204" pitchFamily="34" charset="0"/>
        <a:buChar char="•"/>
        <a:defRPr sz="1638" kern="1200">
          <a:solidFill>
            <a:schemeClr val="tx1"/>
          </a:solidFill>
          <a:latin typeface="+mn-lt"/>
          <a:ea typeface="+mn-ea"/>
          <a:cs typeface="+mn-cs"/>
        </a:defRPr>
      </a:lvl3pPr>
      <a:lvl4pPr marL="1310404" indent="-187201" algn="l" defTabSz="748802" rtl="0" eaLnBrk="1" latinLnBrk="0" hangingPunct="1">
        <a:lnSpc>
          <a:spcPct val="90000"/>
        </a:lnSpc>
        <a:spcBef>
          <a:spcPts val="409"/>
        </a:spcBef>
        <a:buFont typeface="Arial" panose="020B0604020202020204" pitchFamily="34" charset="0"/>
        <a:buChar char="•"/>
        <a:defRPr sz="1474" kern="1200">
          <a:solidFill>
            <a:schemeClr val="tx1"/>
          </a:solidFill>
          <a:latin typeface="+mn-lt"/>
          <a:ea typeface="+mn-ea"/>
          <a:cs typeface="+mn-cs"/>
        </a:defRPr>
      </a:lvl4pPr>
      <a:lvl5pPr marL="1684805" indent="-187201" algn="l" defTabSz="748802" rtl="0" eaLnBrk="1" latinLnBrk="0" hangingPunct="1">
        <a:lnSpc>
          <a:spcPct val="90000"/>
        </a:lnSpc>
        <a:spcBef>
          <a:spcPts val="409"/>
        </a:spcBef>
        <a:buFont typeface="Arial" panose="020B0604020202020204" pitchFamily="34" charset="0"/>
        <a:buChar char="•"/>
        <a:defRPr sz="1474" kern="1200">
          <a:solidFill>
            <a:schemeClr val="tx1"/>
          </a:solidFill>
          <a:latin typeface="+mn-lt"/>
          <a:ea typeface="+mn-ea"/>
          <a:cs typeface="+mn-cs"/>
        </a:defRPr>
      </a:lvl5pPr>
      <a:lvl6pPr marL="2059206" indent="-187201" algn="l" defTabSz="748802" rtl="0" eaLnBrk="1" latinLnBrk="0" hangingPunct="1">
        <a:lnSpc>
          <a:spcPct val="90000"/>
        </a:lnSpc>
        <a:spcBef>
          <a:spcPts val="409"/>
        </a:spcBef>
        <a:buFont typeface="Arial" panose="020B0604020202020204" pitchFamily="34" charset="0"/>
        <a:buChar char="•"/>
        <a:defRPr sz="1474" kern="1200">
          <a:solidFill>
            <a:schemeClr val="tx1"/>
          </a:solidFill>
          <a:latin typeface="+mn-lt"/>
          <a:ea typeface="+mn-ea"/>
          <a:cs typeface="+mn-cs"/>
        </a:defRPr>
      </a:lvl6pPr>
      <a:lvl7pPr marL="2433607" indent="-187201" algn="l" defTabSz="748802" rtl="0" eaLnBrk="1" latinLnBrk="0" hangingPunct="1">
        <a:lnSpc>
          <a:spcPct val="90000"/>
        </a:lnSpc>
        <a:spcBef>
          <a:spcPts val="409"/>
        </a:spcBef>
        <a:buFont typeface="Arial" panose="020B0604020202020204" pitchFamily="34" charset="0"/>
        <a:buChar char="•"/>
        <a:defRPr sz="1474" kern="1200">
          <a:solidFill>
            <a:schemeClr val="tx1"/>
          </a:solidFill>
          <a:latin typeface="+mn-lt"/>
          <a:ea typeface="+mn-ea"/>
          <a:cs typeface="+mn-cs"/>
        </a:defRPr>
      </a:lvl7pPr>
      <a:lvl8pPr marL="2808008" indent="-187201" algn="l" defTabSz="748802" rtl="0" eaLnBrk="1" latinLnBrk="0" hangingPunct="1">
        <a:lnSpc>
          <a:spcPct val="90000"/>
        </a:lnSpc>
        <a:spcBef>
          <a:spcPts val="409"/>
        </a:spcBef>
        <a:buFont typeface="Arial" panose="020B0604020202020204" pitchFamily="34" charset="0"/>
        <a:buChar char="•"/>
        <a:defRPr sz="1474" kern="1200">
          <a:solidFill>
            <a:schemeClr val="tx1"/>
          </a:solidFill>
          <a:latin typeface="+mn-lt"/>
          <a:ea typeface="+mn-ea"/>
          <a:cs typeface="+mn-cs"/>
        </a:defRPr>
      </a:lvl8pPr>
      <a:lvl9pPr marL="3182409" indent="-187201" algn="l" defTabSz="748802" rtl="0" eaLnBrk="1" latinLnBrk="0" hangingPunct="1">
        <a:lnSpc>
          <a:spcPct val="90000"/>
        </a:lnSpc>
        <a:spcBef>
          <a:spcPts val="409"/>
        </a:spcBef>
        <a:buFont typeface="Arial" panose="020B0604020202020204" pitchFamily="34" charset="0"/>
        <a:buChar char="•"/>
        <a:defRPr sz="147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48802" rtl="0" eaLnBrk="1" latinLnBrk="0" hangingPunct="1">
        <a:defRPr sz="1474" kern="1200">
          <a:solidFill>
            <a:schemeClr val="tx1"/>
          </a:solidFill>
          <a:latin typeface="+mn-lt"/>
          <a:ea typeface="+mn-ea"/>
          <a:cs typeface="+mn-cs"/>
        </a:defRPr>
      </a:lvl1pPr>
      <a:lvl2pPr marL="374401" algn="l" defTabSz="748802" rtl="0" eaLnBrk="1" latinLnBrk="0" hangingPunct="1">
        <a:defRPr sz="1474" kern="1200">
          <a:solidFill>
            <a:schemeClr val="tx1"/>
          </a:solidFill>
          <a:latin typeface="+mn-lt"/>
          <a:ea typeface="+mn-ea"/>
          <a:cs typeface="+mn-cs"/>
        </a:defRPr>
      </a:lvl2pPr>
      <a:lvl3pPr marL="748802" algn="l" defTabSz="748802" rtl="0" eaLnBrk="1" latinLnBrk="0" hangingPunct="1">
        <a:defRPr sz="1474" kern="1200">
          <a:solidFill>
            <a:schemeClr val="tx1"/>
          </a:solidFill>
          <a:latin typeface="+mn-lt"/>
          <a:ea typeface="+mn-ea"/>
          <a:cs typeface="+mn-cs"/>
        </a:defRPr>
      </a:lvl3pPr>
      <a:lvl4pPr marL="1123203" algn="l" defTabSz="748802" rtl="0" eaLnBrk="1" latinLnBrk="0" hangingPunct="1">
        <a:defRPr sz="1474" kern="1200">
          <a:solidFill>
            <a:schemeClr val="tx1"/>
          </a:solidFill>
          <a:latin typeface="+mn-lt"/>
          <a:ea typeface="+mn-ea"/>
          <a:cs typeface="+mn-cs"/>
        </a:defRPr>
      </a:lvl4pPr>
      <a:lvl5pPr marL="1497604" algn="l" defTabSz="748802" rtl="0" eaLnBrk="1" latinLnBrk="0" hangingPunct="1">
        <a:defRPr sz="1474" kern="1200">
          <a:solidFill>
            <a:schemeClr val="tx1"/>
          </a:solidFill>
          <a:latin typeface="+mn-lt"/>
          <a:ea typeface="+mn-ea"/>
          <a:cs typeface="+mn-cs"/>
        </a:defRPr>
      </a:lvl5pPr>
      <a:lvl6pPr marL="1872005" algn="l" defTabSz="748802" rtl="0" eaLnBrk="1" latinLnBrk="0" hangingPunct="1">
        <a:defRPr sz="1474" kern="1200">
          <a:solidFill>
            <a:schemeClr val="tx1"/>
          </a:solidFill>
          <a:latin typeface="+mn-lt"/>
          <a:ea typeface="+mn-ea"/>
          <a:cs typeface="+mn-cs"/>
        </a:defRPr>
      </a:lvl6pPr>
      <a:lvl7pPr marL="2246406" algn="l" defTabSz="748802" rtl="0" eaLnBrk="1" latinLnBrk="0" hangingPunct="1">
        <a:defRPr sz="1474" kern="1200">
          <a:solidFill>
            <a:schemeClr val="tx1"/>
          </a:solidFill>
          <a:latin typeface="+mn-lt"/>
          <a:ea typeface="+mn-ea"/>
          <a:cs typeface="+mn-cs"/>
        </a:defRPr>
      </a:lvl7pPr>
      <a:lvl8pPr marL="2620808" algn="l" defTabSz="748802" rtl="0" eaLnBrk="1" latinLnBrk="0" hangingPunct="1">
        <a:defRPr sz="1474" kern="1200">
          <a:solidFill>
            <a:schemeClr val="tx1"/>
          </a:solidFill>
          <a:latin typeface="+mn-lt"/>
          <a:ea typeface="+mn-ea"/>
          <a:cs typeface="+mn-cs"/>
        </a:defRPr>
      </a:lvl8pPr>
      <a:lvl9pPr marL="2995209" algn="l" defTabSz="748802" rtl="0" eaLnBrk="1" latinLnBrk="0" hangingPunct="1">
        <a:defRPr sz="147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Afbeelding 3"/>
          <p:cNvPicPr>
            <a:picLocks noChangeAspect="1"/>
          </p:cNvPicPr>
          <p:nvPr/>
        </p:nvPicPr>
        <p:blipFill rotWithShape="1">
          <a:blip r:embed="rId2"/>
          <a:srcRect t="8997" r="56057" b="5236"/>
          <a:stretch/>
        </p:blipFill>
        <p:spPr>
          <a:xfrm>
            <a:off x="86520" y="420701"/>
            <a:ext cx="2132021" cy="11670776"/>
          </a:xfrm>
          <a:prstGeom prst="rect">
            <a:avLst/>
          </a:prstGeom>
        </p:spPr>
      </p:pic>
      <p:graphicFrame>
        <p:nvGraphicFramePr>
          <p:cNvPr id="5" name="Tabel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1736643"/>
              </p:ext>
            </p:extLst>
          </p:nvPr>
        </p:nvGraphicFramePr>
        <p:xfrm>
          <a:off x="2242343" y="14287"/>
          <a:ext cx="5168106" cy="1207648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3196">
                  <a:extLst>
                    <a:ext uri="{9D8B030D-6E8A-4147-A177-3AD203B41FA5}">
                      <a16:colId xmlns:a16="http://schemas.microsoft.com/office/drawing/2014/main" val="1765282038"/>
                    </a:ext>
                  </a:extLst>
                </a:gridCol>
                <a:gridCol w="273196">
                  <a:extLst>
                    <a:ext uri="{9D8B030D-6E8A-4147-A177-3AD203B41FA5}">
                      <a16:colId xmlns:a16="http://schemas.microsoft.com/office/drawing/2014/main" val="2785800918"/>
                    </a:ext>
                  </a:extLst>
                </a:gridCol>
                <a:gridCol w="273196">
                  <a:extLst>
                    <a:ext uri="{9D8B030D-6E8A-4147-A177-3AD203B41FA5}">
                      <a16:colId xmlns:a16="http://schemas.microsoft.com/office/drawing/2014/main" val="3275595636"/>
                    </a:ext>
                  </a:extLst>
                </a:gridCol>
                <a:gridCol w="27183">
                  <a:extLst>
                    <a:ext uri="{9D8B030D-6E8A-4147-A177-3AD203B41FA5}">
                      <a16:colId xmlns:a16="http://schemas.microsoft.com/office/drawing/2014/main" val="2862425072"/>
                    </a:ext>
                  </a:extLst>
                </a:gridCol>
                <a:gridCol w="273196">
                  <a:extLst>
                    <a:ext uri="{9D8B030D-6E8A-4147-A177-3AD203B41FA5}">
                      <a16:colId xmlns:a16="http://schemas.microsoft.com/office/drawing/2014/main" val="341411216"/>
                    </a:ext>
                  </a:extLst>
                </a:gridCol>
                <a:gridCol w="273196">
                  <a:extLst>
                    <a:ext uri="{9D8B030D-6E8A-4147-A177-3AD203B41FA5}">
                      <a16:colId xmlns:a16="http://schemas.microsoft.com/office/drawing/2014/main" val="3479012171"/>
                    </a:ext>
                  </a:extLst>
                </a:gridCol>
                <a:gridCol w="273196">
                  <a:extLst>
                    <a:ext uri="{9D8B030D-6E8A-4147-A177-3AD203B41FA5}">
                      <a16:colId xmlns:a16="http://schemas.microsoft.com/office/drawing/2014/main" val="1962119733"/>
                    </a:ext>
                  </a:extLst>
                </a:gridCol>
                <a:gridCol w="27183">
                  <a:extLst>
                    <a:ext uri="{9D8B030D-6E8A-4147-A177-3AD203B41FA5}">
                      <a16:colId xmlns:a16="http://schemas.microsoft.com/office/drawing/2014/main" val="3595072511"/>
                    </a:ext>
                  </a:extLst>
                </a:gridCol>
                <a:gridCol w="273196">
                  <a:extLst>
                    <a:ext uri="{9D8B030D-6E8A-4147-A177-3AD203B41FA5}">
                      <a16:colId xmlns:a16="http://schemas.microsoft.com/office/drawing/2014/main" val="316235928"/>
                    </a:ext>
                  </a:extLst>
                </a:gridCol>
                <a:gridCol w="273196">
                  <a:extLst>
                    <a:ext uri="{9D8B030D-6E8A-4147-A177-3AD203B41FA5}">
                      <a16:colId xmlns:a16="http://schemas.microsoft.com/office/drawing/2014/main" val="2228923356"/>
                    </a:ext>
                  </a:extLst>
                </a:gridCol>
                <a:gridCol w="273196">
                  <a:extLst>
                    <a:ext uri="{9D8B030D-6E8A-4147-A177-3AD203B41FA5}">
                      <a16:colId xmlns:a16="http://schemas.microsoft.com/office/drawing/2014/main" val="552236324"/>
                    </a:ext>
                  </a:extLst>
                </a:gridCol>
                <a:gridCol w="27183">
                  <a:extLst>
                    <a:ext uri="{9D8B030D-6E8A-4147-A177-3AD203B41FA5}">
                      <a16:colId xmlns:a16="http://schemas.microsoft.com/office/drawing/2014/main" val="73741166"/>
                    </a:ext>
                  </a:extLst>
                </a:gridCol>
                <a:gridCol w="273196">
                  <a:extLst>
                    <a:ext uri="{9D8B030D-6E8A-4147-A177-3AD203B41FA5}">
                      <a16:colId xmlns:a16="http://schemas.microsoft.com/office/drawing/2014/main" val="3231718829"/>
                    </a:ext>
                  </a:extLst>
                </a:gridCol>
                <a:gridCol w="273196">
                  <a:extLst>
                    <a:ext uri="{9D8B030D-6E8A-4147-A177-3AD203B41FA5}">
                      <a16:colId xmlns:a16="http://schemas.microsoft.com/office/drawing/2014/main" val="3288689111"/>
                    </a:ext>
                  </a:extLst>
                </a:gridCol>
                <a:gridCol w="273196">
                  <a:extLst>
                    <a:ext uri="{9D8B030D-6E8A-4147-A177-3AD203B41FA5}">
                      <a16:colId xmlns:a16="http://schemas.microsoft.com/office/drawing/2014/main" val="2312899998"/>
                    </a:ext>
                  </a:extLst>
                </a:gridCol>
                <a:gridCol w="27183">
                  <a:extLst>
                    <a:ext uri="{9D8B030D-6E8A-4147-A177-3AD203B41FA5}">
                      <a16:colId xmlns:a16="http://schemas.microsoft.com/office/drawing/2014/main" val="298942415"/>
                    </a:ext>
                  </a:extLst>
                </a:gridCol>
                <a:gridCol w="699224">
                  <a:extLst>
                    <a:ext uri="{9D8B030D-6E8A-4147-A177-3AD203B41FA5}">
                      <a16:colId xmlns:a16="http://schemas.microsoft.com/office/drawing/2014/main" val="3436307278"/>
                    </a:ext>
                  </a:extLst>
                </a:gridCol>
                <a:gridCol w="27183">
                  <a:extLst>
                    <a:ext uri="{9D8B030D-6E8A-4147-A177-3AD203B41FA5}">
                      <a16:colId xmlns:a16="http://schemas.microsoft.com/office/drawing/2014/main" val="1771449094"/>
                    </a:ext>
                  </a:extLst>
                </a:gridCol>
                <a:gridCol w="691297">
                  <a:extLst>
                    <a:ext uri="{9D8B030D-6E8A-4147-A177-3AD203B41FA5}">
                      <a16:colId xmlns:a16="http://schemas.microsoft.com/office/drawing/2014/main" val="4007229370"/>
                    </a:ext>
                  </a:extLst>
                </a:gridCol>
                <a:gridCol w="27183">
                  <a:extLst>
                    <a:ext uri="{9D8B030D-6E8A-4147-A177-3AD203B41FA5}">
                      <a16:colId xmlns:a16="http://schemas.microsoft.com/office/drawing/2014/main" val="4205457825"/>
                    </a:ext>
                  </a:extLst>
                </a:gridCol>
                <a:gridCol w="336135">
                  <a:extLst>
                    <a:ext uri="{9D8B030D-6E8A-4147-A177-3AD203B41FA5}">
                      <a16:colId xmlns:a16="http://schemas.microsoft.com/office/drawing/2014/main" val="3082620940"/>
                    </a:ext>
                  </a:extLst>
                </a:gridCol>
              </a:tblGrid>
              <a:tr h="180246">
                <a:tc gridSpan="3"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M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nl-NL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l-NL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endParaRPr lang="nl-NL" sz="10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M3-I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nl-NL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l-NL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endParaRPr lang="nl-NL" sz="10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M3-II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nl-NL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l-NL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endParaRPr lang="nl-NL" sz="10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M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nl-NL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l-NL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ID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Country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Clade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1400673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 smtClean="0">
                          <a:solidFill>
                            <a:schemeClr val="tx1"/>
                          </a:solidFill>
                        </a:rPr>
                        <a:t>a</a:t>
                      </a:r>
                      <a:endParaRPr lang="nl-NL" sz="10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 smtClean="0">
                          <a:solidFill>
                            <a:schemeClr val="tx1"/>
                          </a:solidFill>
                        </a:rPr>
                        <a:t>b</a:t>
                      </a:r>
                      <a:endParaRPr lang="nl-NL" sz="10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 smtClean="0">
                          <a:solidFill>
                            <a:schemeClr val="tx1"/>
                          </a:solidFill>
                        </a:rPr>
                        <a:t>c</a:t>
                      </a:r>
                      <a:endParaRPr lang="nl-NL" sz="10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381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nl-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 smtClean="0">
                          <a:solidFill>
                            <a:schemeClr val="tx1"/>
                          </a:solidFill>
                        </a:rPr>
                        <a:t>a</a:t>
                      </a:r>
                      <a:endParaRPr lang="nl-NL" sz="10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381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 smtClean="0">
                          <a:solidFill>
                            <a:schemeClr val="tx1"/>
                          </a:solidFill>
                        </a:rPr>
                        <a:t>b</a:t>
                      </a:r>
                      <a:endParaRPr lang="nl-NL" sz="10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 smtClean="0">
                          <a:solidFill>
                            <a:schemeClr val="tx1"/>
                          </a:solidFill>
                        </a:rPr>
                        <a:t>c</a:t>
                      </a:r>
                      <a:endParaRPr lang="nl-NL" sz="10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381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nl-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 smtClean="0">
                          <a:solidFill>
                            <a:schemeClr val="tx1"/>
                          </a:solidFill>
                        </a:rPr>
                        <a:t>a</a:t>
                      </a:r>
                      <a:endParaRPr lang="nl-NL" sz="10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381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 smtClean="0">
                          <a:solidFill>
                            <a:schemeClr val="tx1"/>
                          </a:solidFill>
                        </a:rPr>
                        <a:t>b</a:t>
                      </a:r>
                      <a:endParaRPr lang="nl-NL" sz="10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 smtClean="0">
                          <a:solidFill>
                            <a:schemeClr val="tx1"/>
                          </a:solidFill>
                        </a:rPr>
                        <a:t>c</a:t>
                      </a:r>
                      <a:endParaRPr lang="nl-NL" sz="10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381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nl-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 smtClean="0">
                          <a:solidFill>
                            <a:schemeClr val="tx1"/>
                          </a:solidFill>
                        </a:rPr>
                        <a:t>a</a:t>
                      </a:r>
                      <a:endParaRPr lang="nl-NL" sz="10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381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 smtClean="0">
                          <a:solidFill>
                            <a:schemeClr val="tx1"/>
                          </a:solidFill>
                        </a:rPr>
                        <a:t>b</a:t>
                      </a:r>
                      <a:endParaRPr lang="nl-NL" sz="10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 smtClean="0">
                          <a:solidFill>
                            <a:schemeClr val="tx1"/>
                          </a:solidFill>
                        </a:rPr>
                        <a:t>c</a:t>
                      </a:r>
                      <a:endParaRPr lang="nl-NL" sz="10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381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nl-NL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29634724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3-13-0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uwait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5"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I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0856597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1-13-17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dia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78603784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3-03-74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dia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0060772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3-09-84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azil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1447461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3-05-26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uwait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061635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2-12-18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dia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703292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08-13-13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uwait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313136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2-16-85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dia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8336544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3-13-09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uwait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9633840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3-15-86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uwait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5283830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05-13-95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dia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5219433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4-04-57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eece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0503925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05-12-4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dia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5814699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2-18-17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kistan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6601572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5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3-09-86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azil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4059352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5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05-12-41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dia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0170750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3-03-68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dia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44687423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3-15-89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uwait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459642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1-10-21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man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7113422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4-04-56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eece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305217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3-13-07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uwait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7014990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3-13-15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uwait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1924948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05-13-96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dia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9144225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2-17-85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dia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4615599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1-10-24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man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2828772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2-18-26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kistan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2846935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5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1-10-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man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9321787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08-13-15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uwait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7075399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2-17-79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dia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5053834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5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3-14-35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uwait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1032829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1-13-09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dia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1627352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3-14-41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uwait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9313392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3-14-39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uwait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2447896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3-14-50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azil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4987850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13-13-08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uwait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3467472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08-12-0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Spain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10"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III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1068811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08-12-0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Spain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553779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05-15-5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South Africa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0264178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05-15-5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South</a:t>
                      </a:r>
                      <a:r>
                        <a:rPr lang="nl-NL" sz="1000" baseline="0" dirty="0" smtClean="0">
                          <a:solidFill>
                            <a:schemeClr val="tx1"/>
                          </a:solidFill>
                        </a:rPr>
                        <a:t> Africa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445910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08-12-0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Spain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7860382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05-15-4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South Africa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527613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08-11-9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Spain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11017283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08-11-9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Spain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0024062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08-12-0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Spain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804893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05-15-5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South Africa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6385797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5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03-10-6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Japan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II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8098204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5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03-10-6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South Korea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73791290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4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03-10-6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South Korea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72495290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5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13-09-82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Colombia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12"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IV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4667914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5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21-06-3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Brazil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6305954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5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11-15-4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Colombia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9501948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5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11-14-4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Colombia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4776722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5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11-14-0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Nigeria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2226270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5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11-03-6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Venezuela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8022553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5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13-09-8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Nigeria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70192528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5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21-06-3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Brazil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6745971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5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21-06-2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Brazil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5069889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5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3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08-01-0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Venezuela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1713095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5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21-07-0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Brazil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7497687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5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3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5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05-15-2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err="1" smtClean="0">
                          <a:solidFill>
                            <a:schemeClr val="tx1"/>
                          </a:solidFill>
                        </a:rPr>
                        <a:t>Venezual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65183998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13-10-57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Iran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V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8253357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13-08-5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Iran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7628130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13-10-5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Iran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0569614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13-10-9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Iran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7004358"/>
                  </a:ext>
                </a:extLst>
              </a:tr>
              <a:tr h="180246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0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4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2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10-11-10-18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 smtClean="0">
                          <a:solidFill>
                            <a:schemeClr val="tx1"/>
                          </a:solidFill>
                        </a:rPr>
                        <a:t>Iran</a:t>
                      </a:r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5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6024487"/>
                  </a:ext>
                </a:extLst>
              </a:tr>
            </a:tbl>
          </a:graphicData>
        </a:graphic>
      </p:graphicFrame>
      <p:cxnSp>
        <p:nvCxnSpPr>
          <p:cNvPr id="7" name="Rechte verbindingslijn 6"/>
          <p:cNvCxnSpPr/>
          <p:nvPr/>
        </p:nvCxnSpPr>
        <p:spPr>
          <a:xfrm flipH="1" flipV="1">
            <a:off x="30956" y="376236"/>
            <a:ext cx="21240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Rechte verbindingslijn 9"/>
          <p:cNvCxnSpPr/>
          <p:nvPr/>
        </p:nvCxnSpPr>
        <p:spPr>
          <a:xfrm flipH="1" flipV="1">
            <a:off x="2150269" y="308998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Rechte verbindingslijn 10"/>
          <p:cNvCxnSpPr/>
          <p:nvPr/>
        </p:nvCxnSpPr>
        <p:spPr>
          <a:xfrm flipH="1" flipV="1">
            <a:off x="1725469" y="308998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Rechte verbindingslijn 13"/>
          <p:cNvCxnSpPr/>
          <p:nvPr/>
        </p:nvCxnSpPr>
        <p:spPr>
          <a:xfrm flipH="1" flipV="1">
            <a:off x="1300669" y="308998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Rechte verbindingslijn 14"/>
          <p:cNvCxnSpPr/>
          <p:nvPr/>
        </p:nvCxnSpPr>
        <p:spPr>
          <a:xfrm flipH="1" flipV="1">
            <a:off x="875869" y="308998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Rechte verbindingslijn 15"/>
          <p:cNvCxnSpPr/>
          <p:nvPr/>
        </p:nvCxnSpPr>
        <p:spPr>
          <a:xfrm flipH="1" flipV="1">
            <a:off x="455401" y="308713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kstvak 16"/>
          <p:cNvSpPr txBox="1"/>
          <p:nvPr/>
        </p:nvSpPr>
        <p:spPr>
          <a:xfrm>
            <a:off x="35716" y="378620"/>
            <a:ext cx="89960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err="1" smtClean="0"/>
              <a:t>Similarity</a:t>
            </a:r>
            <a:r>
              <a:rPr lang="nl-NL" sz="1000" dirty="0" smtClean="0"/>
              <a:t> (%)</a:t>
            </a:r>
            <a:endParaRPr lang="nl-NL" sz="1000" dirty="0"/>
          </a:p>
        </p:txBody>
      </p:sp>
      <p:sp>
        <p:nvSpPr>
          <p:cNvPr id="18" name="Tekstvak 17"/>
          <p:cNvSpPr txBox="1"/>
          <p:nvPr/>
        </p:nvSpPr>
        <p:spPr>
          <a:xfrm>
            <a:off x="1959351" y="72441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smtClean="0"/>
              <a:t>100</a:t>
            </a:r>
            <a:endParaRPr lang="nl-NL" sz="1000" dirty="0"/>
          </a:p>
        </p:txBody>
      </p:sp>
      <p:sp>
        <p:nvSpPr>
          <p:cNvPr id="19" name="Tekstvak 18"/>
          <p:cNvSpPr txBox="1"/>
          <p:nvPr/>
        </p:nvSpPr>
        <p:spPr>
          <a:xfrm>
            <a:off x="1569794" y="7185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80</a:t>
            </a:r>
            <a:endParaRPr lang="nl-NL" sz="1000" dirty="0"/>
          </a:p>
        </p:txBody>
      </p:sp>
      <p:sp>
        <p:nvSpPr>
          <p:cNvPr id="20" name="Tekstvak 19"/>
          <p:cNvSpPr txBox="1"/>
          <p:nvPr/>
        </p:nvSpPr>
        <p:spPr>
          <a:xfrm>
            <a:off x="1143775" y="74146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/>
              <a:t>6</a:t>
            </a:r>
            <a:r>
              <a:rPr lang="nl-NL" sz="1000" dirty="0" smtClean="0"/>
              <a:t>0</a:t>
            </a:r>
            <a:endParaRPr lang="nl-NL" sz="1000" dirty="0"/>
          </a:p>
        </p:txBody>
      </p:sp>
      <p:sp>
        <p:nvSpPr>
          <p:cNvPr id="21" name="Tekstvak 20"/>
          <p:cNvSpPr txBox="1"/>
          <p:nvPr/>
        </p:nvSpPr>
        <p:spPr>
          <a:xfrm>
            <a:off x="720247" y="7185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40</a:t>
            </a:r>
            <a:endParaRPr lang="nl-NL" sz="1000" dirty="0"/>
          </a:p>
        </p:txBody>
      </p:sp>
      <p:sp>
        <p:nvSpPr>
          <p:cNvPr id="22" name="Tekstvak 21"/>
          <p:cNvSpPr txBox="1"/>
          <p:nvPr/>
        </p:nvSpPr>
        <p:spPr>
          <a:xfrm>
            <a:off x="301321" y="66314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/>
              <a:t>2</a:t>
            </a:r>
            <a:r>
              <a:rPr lang="nl-NL" sz="1000" dirty="0" smtClean="0"/>
              <a:t>0</a:t>
            </a:r>
            <a:endParaRPr lang="nl-NL" sz="1000" dirty="0"/>
          </a:p>
        </p:txBody>
      </p:sp>
    </p:spTree>
    <p:extLst>
      <p:ext uri="{BB962C8B-B14F-4D97-AF65-F5344CB8AC3E}">
        <p14:creationId xmlns:p14="http://schemas.microsoft.com/office/powerpoint/2010/main" val="10155648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th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</TotalTime>
  <Words>947</Words>
  <Application>Microsoft Office PowerPoint</Application>
  <PresentationFormat>Aangepast</PresentationFormat>
  <Paragraphs>940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Kantoorthema</vt:lpstr>
      <vt:lpstr>PowerPoint-presentatie</vt:lpstr>
    </vt:vector>
  </TitlesOfParts>
  <Company>CWZ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Bram Spruijtenburg</dc:creator>
  <cp:lastModifiedBy>Bram Spruijtenburg</cp:lastModifiedBy>
  <cp:revision>2</cp:revision>
  <dcterms:created xsi:type="dcterms:W3CDTF">2024-12-12T20:36:50Z</dcterms:created>
  <dcterms:modified xsi:type="dcterms:W3CDTF">2024-12-12T21:26:51Z</dcterms:modified>
</cp:coreProperties>
</file>